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361019A-BF92-4CDD-805D-01D6A06CCAF2}" v="37" dt="2024-11-14T09:00:53.23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83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daf Naqvi" userId="8f91277e-8741-4995-819e-50b4e5326a9f" providerId="ADAL" clId="{5361019A-BF92-4CDD-805D-01D6A06CCAF2}"/>
    <pc:docChg chg="undo custSel addSld delSld modSld">
      <pc:chgData name="Sadaf Naqvi" userId="8f91277e-8741-4995-819e-50b4e5326a9f" providerId="ADAL" clId="{5361019A-BF92-4CDD-805D-01D6A06CCAF2}" dt="2024-11-14T09:00:59.208" v="495" actId="1076"/>
      <pc:docMkLst>
        <pc:docMk/>
      </pc:docMkLst>
      <pc:sldChg chg="modSp del mod">
        <pc:chgData name="Sadaf Naqvi" userId="8f91277e-8741-4995-819e-50b4e5326a9f" providerId="ADAL" clId="{5361019A-BF92-4CDD-805D-01D6A06CCAF2}" dt="2024-11-06T12:49:21.531" v="13" actId="2696"/>
        <pc:sldMkLst>
          <pc:docMk/>
          <pc:sldMk cId="2581505682" sldId="256"/>
        </pc:sldMkLst>
        <pc:spChg chg="mod">
          <ac:chgData name="Sadaf Naqvi" userId="8f91277e-8741-4995-819e-50b4e5326a9f" providerId="ADAL" clId="{5361019A-BF92-4CDD-805D-01D6A06CCAF2}" dt="2024-11-06T09:08:54.118" v="12" actId="20577"/>
          <ac:spMkLst>
            <pc:docMk/>
            <pc:sldMk cId="2581505682" sldId="256"/>
            <ac:spMk id="2" creationId="{5C6BD896-DB52-E558-B85D-BCE7DC1D76BD}"/>
          </ac:spMkLst>
        </pc:spChg>
      </pc:sldChg>
      <pc:sldChg chg="del">
        <pc:chgData name="Sadaf Naqvi" userId="8f91277e-8741-4995-819e-50b4e5326a9f" providerId="ADAL" clId="{5361019A-BF92-4CDD-805D-01D6A06CCAF2}" dt="2024-11-14T08:46:15.288" v="18" actId="2696"/>
        <pc:sldMkLst>
          <pc:docMk/>
          <pc:sldMk cId="2828968604" sldId="257"/>
        </pc:sldMkLst>
      </pc:sldChg>
      <pc:sldChg chg="addSp delSp modSp new del mod">
        <pc:chgData name="Sadaf Naqvi" userId="8f91277e-8741-4995-819e-50b4e5326a9f" providerId="ADAL" clId="{5361019A-BF92-4CDD-805D-01D6A06CCAF2}" dt="2024-11-14T08:46:08.280" v="15" actId="2696"/>
        <pc:sldMkLst>
          <pc:docMk/>
          <pc:sldMk cId="2496051410" sldId="258"/>
        </pc:sldMkLst>
        <pc:spChg chg="mod">
          <ac:chgData name="Sadaf Naqvi" userId="8f91277e-8741-4995-819e-50b4e5326a9f" providerId="ADAL" clId="{5361019A-BF92-4CDD-805D-01D6A06CCAF2}" dt="2024-11-06T09:07:21.113" v="4" actId="20577"/>
          <ac:spMkLst>
            <pc:docMk/>
            <pc:sldMk cId="2496051410" sldId="258"/>
            <ac:spMk id="2" creationId="{40F46B62-FE3B-A1FB-59B0-FAC0EFE5C2C6}"/>
          </ac:spMkLst>
        </pc:spChg>
        <pc:spChg chg="del">
          <ac:chgData name="Sadaf Naqvi" userId="8f91277e-8741-4995-819e-50b4e5326a9f" providerId="ADAL" clId="{5361019A-BF92-4CDD-805D-01D6A06CCAF2}" dt="2024-11-06T09:07:07.734" v="1"/>
          <ac:spMkLst>
            <pc:docMk/>
            <pc:sldMk cId="2496051410" sldId="258"/>
            <ac:spMk id="3" creationId="{49848DC7-A2B3-E841-0C80-81976BD6250A}"/>
          </ac:spMkLst>
        </pc:spChg>
        <pc:picChg chg="add mod">
          <ac:chgData name="Sadaf Naqvi" userId="8f91277e-8741-4995-819e-50b4e5326a9f" providerId="ADAL" clId="{5361019A-BF92-4CDD-805D-01D6A06CCAF2}" dt="2024-11-06T09:07:07.734" v="1"/>
          <ac:picMkLst>
            <pc:docMk/>
            <pc:sldMk cId="2496051410" sldId="258"/>
            <ac:picMk id="4" creationId="{9FF74736-7F07-DD02-ADEF-BE09F886B7D1}"/>
          </ac:picMkLst>
        </pc:picChg>
      </pc:sldChg>
      <pc:sldChg chg="addSp delSp modSp new mod">
        <pc:chgData name="Sadaf Naqvi" userId="8f91277e-8741-4995-819e-50b4e5326a9f" providerId="ADAL" clId="{5361019A-BF92-4CDD-805D-01D6A06CCAF2}" dt="2024-11-14T09:00:59.208" v="495" actId="1076"/>
        <pc:sldMkLst>
          <pc:docMk/>
          <pc:sldMk cId="1453174751" sldId="259"/>
        </pc:sldMkLst>
        <pc:spChg chg="mod">
          <ac:chgData name="Sadaf Naqvi" userId="8f91277e-8741-4995-819e-50b4e5326a9f" providerId="ADAL" clId="{5361019A-BF92-4CDD-805D-01D6A06CCAF2}" dt="2024-11-14T08:48:59.125" v="133" actId="20577"/>
          <ac:spMkLst>
            <pc:docMk/>
            <pc:sldMk cId="1453174751" sldId="259"/>
            <ac:spMk id="2" creationId="{149C5A39-AD4F-1D04-8BB5-29F52A41180F}"/>
          </ac:spMkLst>
        </pc:spChg>
        <pc:spChg chg="del">
          <ac:chgData name="Sadaf Naqvi" userId="8f91277e-8741-4995-819e-50b4e5326a9f" providerId="ADAL" clId="{5361019A-BF92-4CDD-805D-01D6A06CCAF2}" dt="2024-11-14T08:46:45.967" v="19" actId="478"/>
          <ac:spMkLst>
            <pc:docMk/>
            <pc:sldMk cId="1453174751" sldId="259"/>
            <ac:spMk id="3" creationId="{F0B1E7BA-5EAB-053D-0DAE-7D89C012F980}"/>
          </ac:spMkLst>
        </pc:spChg>
        <pc:spChg chg="add mod">
          <ac:chgData name="Sadaf Naqvi" userId="8f91277e-8741-4995-819e-50b4e5326a9f" providerId="ADAL" clId="{5361019A-BF92-4CDD-805D-01D6A06CCAF2}" dt="2024-11-14T08:49:26.975" v="137" actId="207"/>
          <ac:spMkLst>
            <pc:docMk/>
            <pc:sldMk cId="1453174751" sldId="259"/>
            <ac:spMk id="4" creationId="{0AE6096C-A769-2A69-AC59-2F70E39B37BF}"/>
          </ac:spMkLst>
        </pc:spChg>
        <pc:spChg chg="add mod">
          <ac:chgData name="Sadaf Naqvi" userId="8f91277e-8741-4995-819e-50b4e5326a9f" providerId="ADAL" clId="{5361019A-BF92-4CDD-805D-01D6A06CCAF2}" dt="2024-11-14T08:50:02.650" v="145" actId="207"/>
          <ac:spMkLst>
            <pc:docMk/>
            <pc:sldMk cId="1453174751" sldId="259"/>
            <ac:spMk id="5" creationId="{928A6FFF-3A73-A755-ED9A-0EBEDF165257}"/>
          </ac:spMkLst>
        </pc:spChg>
        <pc:spChg chg="add mod">
          <ac:chgData name="Sadaf Naqvi" userId="8f91277e-8741-4995-819e-50b4e5326a9f" providerId="ADAL" clId="{5361019A-BF92-4CDD-805D-01D6A06CCAF2}" dt="2024-11-14T08:50:06.506" v="146" actId="207"/>
          <ac:spMkLst>
            <pc:docMk/>
            <pc:sldMk cId="1453174751" sldId="259"/>
            <ac:spMk id="6" creationId="{F5FCFD82-A3A2-815F-67F9-929404DEF833}"/>
          </ac:spMkLst>
        </pc:spChg>
        <pc:spChg chg="add mod">
          <ac:chgData name="Sadaf Naqvi" userId="8f91277e-8741-4995-819e-50b4e5326a9f" providerId="ADAL" clId="{5361019A-BF92-4CDD-805D-01D6A06CCAF2}" dt="2024-11-14T08:50:11.572" v="147" actId="207"/>
          <ac:spMkLst>
            <pc:docMk/>
            <pc:sldMk cId="1453174751" sldId="259"/>
            <ac:spMk id="7" creationId="{1CF77738-D924-2A8C-8051-EECC1067359B}"/>
          </ac:spMkLst>
        </pc:spChg>
        <pc:spChg chg="add mod">
          <ac:chgData name="Sadaf Naqvi" userId="8f91277e-8741-4995-819e-50b4e5326a9f" providerId="ADAL" clId="{5361019A-BF92-4CDD-805D-01D6A06CCAF2}" dt="2024-11-14T08:50:31.956" v="171" actId="1076"/>
          <ac:spMkLst>
            <pc:docMk/>
            <pc:sldMk cId="1453174751" sldId="259"/>
            <ac:spMk id="8" creationId="{413C2876-5C6F-DF3D-1425-4176C96610EC}"/>
          </ac:spMkLst>
        </pc:spChg>
        <pc:spChg chg="add mod">
          <ac:chgData name="Sadaf Naqvi" userId="8f91277e-8741-4995-819e-50b4e5326a9f" providerId="ADAL" clId="{5361019A-BF92-4CDD-805D-01D6A06CCAF2}" dt="2024-11-14T08:51:08.648" v="199" actId="122"/>
          <ac:spMkLst>
            <pc:docMk/>
            <pc:sldMk cId="1453174751" sldId="259"/>
            <ac:spMk id="9" creationId="{E39C2A00-AFCB-224C-68DF-DE325FC610DA}"/>
          </ac:spMkLst>
        </pc:spChg>
        <pc:spChg chg="add mod">
          <ac:chgData name="Sadaf Naqvi" userId="8f91277e-8741-4995-819e-50b4e5326a9f" providerId="ADAL" clId="{5361019A-BF92-4CDD-805D-01D6A06CCAF2}" dt="2024-11-14T08:51:28.267" v="214" actId="20577"/>
          <ac:spMkLst>
            <pc:docMk/>
            <pc:sldMk cId="1453174751" sldId="259"/>
            <ac:spMk id="10" creationId="{0A321AF4-2542-7608-41ED-CD336D636C29}"/>
          </ac:spMkLst>
        </pc:spChg>
        <pc:spChg chg="add mod">
          <ac:chgData name="Sadaf Naqvi" userId="8f91277e-8741-4995-819e-50b4e5326a9f" providerId="ADAL" clId="{5361019A-BF92-4CDD-805D-01D6A06CCAF2}" dt="2024-11-14T08:51:55.672" v="237" actId="1076"/>
          <ac:spMkLst>
            <pc:docMk/>
            <pc:sldMk cId="1453174751" sldId="259"/>
            <ac:spMk id="11" creationId="{7C41264C-F660-2E93-B27C-5411A1E1BB66}"/>
          </ac:spMkLst>
        </pc:spChg>
        <pc:spChg chg="add mod">
          <ac:chgData name="Sadaf Naqvi" userId="8f91277e-8741-4995-819e-50b4e5326a9f" providerId="ADAL" clId="{5361019A-BF92-4CDD-805D-01D6A06CCAF2}" dt="2024-11-14T08:52:11.809" v="239" actId="1076"/>
          <ac:spMkLst>
            <pc:docMk/>
            <pc:sldMk cId="1453174751" sldId="259"/>
            <ac:spMk id="12" creationId="{14971E17-7F66-C107-2447-7DD0B78C98D5}"/>
          </ac:spMkLst>
        </pc:spChg>
        <pc:spChg chg="add mod">
          <ac:chgData name="Sadaf Naqvi" userId="8f91277e-8741-4995-819e-50b4e5326a9f" providerId="ADAL" clId="{5361019A-BF92-4CDD-805D-01D6A06CCAF2}" dt="2024-11-14T08:52:22.092" v="241" actId="1076"/>
          <ac:spMkLst>
            <pc:docMk/>
            <pc:sldMk cId="1453174751" sldId="259"/>
            <ac:spMk id="13" creationId="{8804DDC9-80DA-0163-C2D7-F668418F5EA2}"/>
          </ac:spMkLst>
        </pc:spChg>
        <pc:spChg chg="add mod">
          <ac:chgData name="Sadaf Naqvi" userId="8f91277e-8741-4995-819e-50b4e5326a9f" providerId="ADAL" clId="{5361019A-BF92-4CDD-805D-01D6A06CCAF2}" dt="2024-11-14T08:52:26.914" v="243" actId="1076"/>
          <ac:spMkLst>
            <pc:docMk/>
            <pc:sldMk cId="1453174751" sldId="259"/>
            <ac:spMk id="14" creationId="{FA2415E5-D269-57E6-B013-7445CBE03921}"/>
          </ac:spMkLst>
        </pc:spChg>
        <pc:spChg chg="add mod">
          <ac:chgData name="Sadaf Naqvi" userId="8f91277e-8741-4995-819e-50b4e5326a9f" providerId="ADAL" clId="{5361019A-BF92-4CDD-805D-01D6A06CCAF2}" dt="2024-11-14T08:52:50.871" v="259" actId="20577"/>
          <ac:spMkLst>
            <pc:docMk/>
            <pc:sldMk cId="1453174751" sldId="259"/>
            <ac:spMk id="15" creationId="{DA9B2BD7-609B-F3C9-093B-704D6B1CB8FD}"/>
          </ac:spMkLst>
        </pc:spChg>
        <pc:spChg chg="add mod">
          <ac:chgData name="Sadaf Naqvi" userId="8f91277e-8741-4995-819e-50b4e5326a9f" providerId="ADAL" clId="{5361019A-BF92-4CDD-805D-01D6A06CCAF2}" dt="2024-11-14T08:53:11.484" v="283" actId="20577"/>
          <ac:spMkLst>
            <pc:docMk/>
            <pc:sldMk cId="1453174751" sldId="259"/>
            <ac:spMk id="16" creationId="{547EEA36-2431-DE89-1E0B-0C37A7D539DC}"/>
          </ac:spMkLst>
        </pc:spChg>
        <pc:spChg chg="add mod">
          <ac:chgData name="Sadaf Naqvi" userId="8f91277e-8741-4995-819e-50b4e5326a9f" providerId="ADAL" clId="{5361019A-BF92-4CDD-805D-01D6A06CCAF2}" dt="2024-11-14T08:53:29.103" v="308" actId="20577"/>
          <ac:spMkLst>
            <pc:docMk/>
            <pc:sldMk cId="1453174751" sldId="259"/>
            <ac:spMk id="17" creationId="{7765BDC7-D00A-F961-C63F-290A371FD987}"/>
          </ac:spMkLst>
        </pc:spChg>
        <pc:spChg chg="add mod">
          <ac:chgData name="Sadaf Naqvi" userId="8f91277e-8741-4995-819e-50b4e5326a9f" providerId="ADAL" clId="{5361019A-BF92-4CDD-805D-01D6A06CCAF2}" dt="2024-11-14T08:53:57.788" v="313" actId="14100"/>
          <ac:spMkLst>
            <pc:docMk/>
            <pc:sldMk cId="1453174751" sldId="259"/>
            <ac:spMk id="18" creationId="{B7DCF0C1-98B1-1162-3FBF-D08E85918193}"/>
          </ac:spMkLst>
        </pc:spChg>
        <pc:spChg chg="add del mod">
          <ac:chgData name="Sadaf Naqvi" userId="8f91277e-8741-4995-819e-50b4e5326a9f" providerId="ADAL" clId="{5361019A-BF92-4CDD-805D-01D6A06CCAF2}" dt="2024-11-14T08:54:04.174" v="314" actId="478"/>
          <ac:spMkLst>
            <pc:docMk/>
            <pc:sldMk cId="1453174751" sldId="259"/>
            <ac:spMk id="19" creationId="{38AC6550-EEBC-620F-0EBF-B70148B5DF22}"/>
          </ac:spMkLst>
        </pc:spChg>
        <pc:spChg chg="add mod">
          <ac:chgData name="Sadaf Naqvi" userId="8f91277e-8741-4995-819e-50b4e5326a9f" providerId="ADAL" clId="{5361019A-BF92-4CDD-805D-01D6A06CCAF2}" dt="2024-11-14T08:54:08.949" v="316" actId="1076"/>
          <ac:spMkLst>
            <pc:docMk/>
            <pc:sldMk cId="1453174751" sldId="259"/>
            <ac:spMk id="20" creationId="{4577D8F2-4CA9-1059-664A-B6FF19D8F9CB}"/>
          </ac:spMkLst>
        </pc:spChg>
        <pc:spChg chg="add mod">
          <ac:chgData name="Sadaf Naqvi" userId="8f91277e-8741-4995-819e-50b4e5326a9f" providerId="ADAL" clId="{5361019A-BF92-4CDD-805D-01D6A06CCAF2}" dt="2024-11-14T08:55:54.534" v="374" actId="1076"/>
          <ac:spMkLst>
            <pc:docMk/>
            <pc:sldMk cId="1453174751" sldId="259"/>
            <ac:spMk id="21" creationId="{8D23DFC5-0BB7-3073-B835-3F4250B23C30}"/>
          </ac:spMkLst>
        </pc:spChg>
        <pc:spChg chg="add mod">
          <ac:chgData name="Sadaf Naqvi" userId="8f91277e-8741-4995-819e-50b4e5326a9f" providerId="ADAL" clId="{5361019A-BF92-4CDD-805D-01D6A06CCAF2}" dt="2024-11-14T08:55:59.569" v="375" actId="255"/>
          <ac:spMkLst>
            <pc:docMk/>
            <pc:sldMk cId="1453174751" sldId="259"/>
            <ac:spMk id="22" creationId="{F808A97A-F9F9-4F6B-5B32-FC49CDE9BC5D}"/>
          </ac:spMkLst>
        </pc:spChg>
        <pc:spChg chg="add mod">
          <ac:chgData name="Sadaf Naqvi" userId="8f91277e-8741-4995-819e-50b4e5326a9f" providerId="ADAL" clId="{5361019A-BF92-4CDD-805D-01D6A06CCAF2}" dt="2024-11-14T08:55:06.891" v="364"/>
          <ac:spMkLst>
            <pc:docMk/>
            <pc:sldMk cId="1453174751" sldId="259"/>
            <ac:spMk id="23" creationId="{20C2BC78-438B-AE91-3AA6-7118497FF964}"/>
          </ac:spMkLst>
        </pc:spChg>
        <pc:spChg chg="add mod">
          <ac:chgData name="Sadaf Naqvi" userId="8f91277e-8741-4995-819e-50b4e5326a9f" providerId="ADAL" clId="{5361019A-BF92-4CDD-805D-01D6A06CCAF2}" dt="2024-11-14T08:55:22.796" v="366" actId="1076"/>
          <ac:spMkLst>
            <pc:docMk/>
            <pc:sldMk cId="1453174751" sldId="259"/>
            <ac:spMk id="24" creationId="{58201475-2CCB-E270-2012-5767053FBC64}"/>
          </ac:spMkLst>
        </pc:spChg>
        <pc:spChg chg="add mod">
          <ac:chgData name="Sadaf Naqvi" userId="8f91277e-8741-4995-819e-50b4e5326a9f" providerId="ADAL" clId="{5361019A-BF92-4CDD-805D-01D6A06CCAF2}" dt="2024-11-14T08:55:31.156" v="368" actId="1076"/>
          <ac:spMkLst>
            <pc:docMk/>
            <pc:sldMk cId="1453174751" sldId="259"/>
            <ac:spMk id="25" creationId="{E47D2E80-C1E8-5220-F6EF-EEC960C1A26D}"/>
          </ac:spMkLst>
        </pc:spChg>
        <pc:spChg chg="add mod">
          <ac:chgData name="Sadaf Naqvi" userId="8f91277e-8741-4995-819e-50b4e5326a9f" providerId="ADAL" clId="{5361019A-BF92-4CDD-805D-01D6A06CCAF2}" dt="2024-11-14T08:55:39.792" v="370" actId="1076"/>
          <ac:spMkLst>
            <pc:docMk/>
            <pc:sldMk cId="1453174751" sldId="259"/>
            <ac:spMk id="26" creationId="{02C7F486-4B4A-F9B2-C8DC-85BB85F52FDA}"/>
          </ac:spMkLst>
        </pc:spChg>
        <pc:spChg chg="add mod">
          <ac:chgData name="Sadaf Naqvi" userId="8f91277e-8741-4995-819e-50b4e5326a9f" providerId="ADAL" clId="{5361019A-BF92-4CDD-805D-01D6A06CCAF2}" dt="2024-11-14T08:55:44.757" v="372" actId="1076"/>
          <ac:spMkLst>
            <pc:docMk/>
            <pc:sldMk cId="1453174751" sldId="259"/>
            <ac:spMk id="27" creationId="{F6113A5D-09F0-729A-5A32-50B5A5960CD4}"/>
          </ac:spMkLst>
        </pc:spChg>
        <pc:spChg chg="add mod">
          <ac:chgData name="Sadaf Naqvi" userId="8f91277e-8741-4995-819e-50b4e5326a9f" providerId="ADAL" clId="{5361019A-BF92-4CDD-805D-01D6A06CCAF2}" dt="2024-11-14T08:56:11.362" v="387" actId="5793"/>
          <ac:spMkLst>
            <pc:docMk/>
            <pc:sldMk cId="1453174751" sldId="259"/>
            <ac:spMk id="28" creationId="{B09CF38A-B20E-08DD-994E-663895BBFA5B}"/>
          </ac:spMkLst>
        </pc:spChg>
        <pc:spChg chg="add mod">
          <ac:chgData name="Sadaf Naqvi" userId="8f91277e-8741-4995-819e-50b4e5326a9f" providerId="ADAL" clId="{5361019A-BF92-4CDD-805D-01D6A06CCAF2}" dt="2024-11-14T08:56:23.376" v="391" actId="20577"/>
          <ac:spMkLst>
            <pc:docMk/>
            <pc:sldMk cId="1453174751" sldId="259"/>
            <ac:spMk id="29" creationId="{C3F84770-5E16-713C-F991-CC78574FAAD8}"/>
          </ac:spMkLst>
        </pc:spChg>
        <pc:spChg chg="add mod">
          <ac:chgData name="Sadaf Naqvi" userId="8f91277e-8741-4995-819e-50b4e5326a9f" providerId="ADAL" clId="{5361019A-BF92-4CDD-805D-01D6A06CCAF2}" dt="2024-11-14T08:56:54.009" v="422" actId="1076"/>
          <ac:spMkLst>
            <pc:docMk/>
            <pc:sldMk cId="1453174751" sldId="259"/>
            <ac:spMk id="30" creationId="{49F35A1E-8B00-B17C-EE90-BF5C55781338}"/>
          </ac:spMkLst>
        </pc:spChg>
        <pc:spChg chg="add mod">
          <ac:chgData name="Sadaf Naqvi" userId="8f91277e-8741-4995-819e-50b4e5326a9f" providerId="ADAL" clId="{5361019A-BF92-4CDD-805D-01D6A06CCAF2}" dt="2024-11-14T08:57:16.871" v="455" actId="20577"/>
          <ac:spMkLst>
            <pc:docMk/>
            <pc:sldMk cId="1453174751" sldId="259"/>
            <ac:spMk id="31" creationId="{55C1436E-C490-EC1C-B748-D63C583D63A0}"/>
          </ac:spMkLst>
        </pc:spChg>
        <pc:grpChg chg="add mod">
          <ac:chgData name="Sadaf Naqvi" userId="8f91277e-8741-4995-819e-50b4e5326a9f" providerId="ADAL" clId="{5361019A-BF92-4CDD-805D-01D6A06CCAF2}" dt="2024-11-14T09:00:43.835" v="491" actId="164"/>
          <ac:grpSpMkLst>
            <pc:docMk/>
            <pc:sldMk cId="1453174751" sldId="259"/>
            <ac:grpSpMk id="56" creationId="{639A02B2-53F8-5DDE-7338-2B2986772C0F}"/>
          </ac:grpSpMkLst>
        </pc:grpChg>
        <pc:grpChg chg="add mod">
          <ac:chgData name="Sadaf Naqvi" userId="8f91277e-8741-4995-819e-50b4e5326a9f" providerId="ADAL" clId="{5361019A-BF92-4CDD-805D-01D6A06CCAF2}" dt="2024-11-14T09:00:51.767" v="493" actId="1076"/>
          <ac:grpSpMkLst>
            <pc:docMk/>
            <pc:sldMk cId="1453174751" sldId="259"/>
            <ac:grpSpMk id="57" creationId="{F11DF799-9CF3-A234-66D0-2BF30A1FE3AB}"/>
          </ac:grpSpMkLst>
        </pc:grpChg>
        <pc:grpChg chg="add mod">
          <ac:chgData name="Sadaf Naqvi" userId="8f91277e-8741-4995-819e-50b4e5326a9f" providerId="ADAL" clId="{5361019A-BF92-4CDD-805D-01D6A06CCAF2}" dt="2024-11-14T09:00:59.208" v="495" actId="1076"/>
          <ac:grpSpMkLst>
            <pc:docMk/>
            <pc:sldMk cId="1453174751" sldId="259"/>
            <ac:grpSpMk id="62" creationId="{7B3E6414-E5BF-647A-4892-14AD134CA126}"/>
          </ac:grpSpMkLst>
        </pc:grpChg>
        <pc:cxnChg chg="add">
          <ac:chgData name="Sadaf Naqvi" userId="8f91277e-8741-4995-819e-50b4e5326a9f" providerId="ADAL" clId="{5361019A-BF92-4CDD-805D-01D6A06CCAF2}" dt="2024-11-14T08:57:36.752" v="456" actId="11529"/>
          <ac:cxnSpMkLst>
            <pc:docMk/>
            <pc:sldMk cId="1453174751" sldId="259"/>
            <ac:cxnSpMk id="33" creationId="{61D863BC-EDB5-3BA6-6099-4C3B188E6BEE}"/>
          </ac:cxnSpMkLst>
        </pc:cxnChg>
        <pc:cxnChg chg="add mod">
          <ac:chgData name="Sadaf Naqvi" userId="8f91277e-8741-4995-819e-50b4e5326a9f" providerId="ADAL" clId="{5361019A-BF92-4CDD-805D-01D6A06CCAF2}" dt="2024-11-14T08:57:55.766" v="458" actId="1076"/>
          <ac:cxnSpMkLst>
            <pc:docMk/>
            <pc:sldMk cId="1453174751" sldId="259"/>
            <ac:cxnSpMk id="35" creationId="{1F1AF263-0350-BA87-ACDA-B239F5D1604F}"/>
          </ac:cxnSpMkLst>
        </pc:cxnChg>
        <pc:cxnChg chg="add">
          <ac:chgData name="Sadaf Naqvi" userId="8f91277e-8741-4995-819e-50b4e5326a9f" providerId="ADAL" clId="{5361019A-BF92-4CDD-805D-01D6A06CCAF2}" dt="2024-11-14T08:58:02.318" v="459" actId="11529"/>
          <ac:cxnSpMkLst>
            <pc:docMk/>
            <pc:sldMk cId="1453174751" sldId="259"/>
            <ac:cxnSpMk id="37" creationId="{6D907DD3-61A1-C552-3E53-F7F67CEE2E83}"/>
          </ac:cxnSpMkLst>
        </pc:cxnChg>
        <pc:cxnChg chg="add mod">
          <ac:chgData name="Sadaf Naqvi" userId="8f91277e-8741-4995-819e-50b4e5326a9f" providerId="ADAL" clId="{5361019A-BF92-4CDD-805D-01D6A06CCAF2}" dt="2024-11-14T08:58:10.627" v="461" actId="1076"/>
          <ac:cxnSpMkLst>
            <pc:docMk/>
            <pc:sldMk cId="1453174751" sldId="259"/>
            <ac:cxnSpMk id="38" creationId="{C9A459DE-E50E-96F6-4B30-02E4C09B1FA2}"/>
          </ac:cxnSpMkLst>
        </pc:cxnChg>
        <pc:cxnChg chg="add mod">
          <ac:chgData name="Sadaf Naqvi" userId="8f91277e-8741-4995-819e-50b4e5326a9f" providerId="ADAL" clId="{5361019A-BF92-4CDD-805D-01D6A06CCAF2}" dt="2024-11-14T08:58:19.309" v="463" actId="1076"/>
          <ac:cxnSpMkLst>
            <pc:docMk/>
            <pc:sldMk cId="1453174751" sldId="259"/>
            <ac:cxnSpMk id="39" creationId="{165AC379-1BBB-A7AC-7F12-299052C93F1C}"/>
          </ac:cxnSpMkLst>
        </pc:cxnChg>
        <pc:cxnChg chg="add mod">
          <ac:chgData name="Sadaf Naqvi" userId="8f91277e-8741-4995-819e-50b4e5326a9f" providerId="ADAL" clId="{5361019A-BF92-4CDD-805D-01D6A06CCAF2}" dt="2024-11-14T08:58:29.349" v="466" actId="14100"/>
          <ac:cxnSpMkLst>
            <pc:docMk/>
            <pc:sldMk cId="1453174751" sldId="259"/>
            <ac:cxnSpMk id="40" creationId="{894E7169-44C2-8785-91B0-632F5CE482DC}"/>
          </ac:cxnSpMkLst>
        </pc:cxnChg>
        <pc:cxnChg chg="add mod">
          <ac:chgData name="Sadaf Naqvi" userId="8f91277e-8741-4995-819e-50b4e5326a9f" providerId="ADAL" clId="{5361019A-BF92-4CDD-805D-01D6A06CCAF2}" dt="2024-11-14T08:58:38.966" v="468" actId="1076"/>
          <ac:cxnSpMkLst>
            <pc:docMk/>
            <pc:sldMk cId="1453174751" sldId="259"/>
            <ac:cxnSpMk id="42" creationId="{DC592D87-DEF6-952B-5D8A-5CB41BD7CE70}"/>
          </ac:cxnSpMkLst>
        </pc:cxnChg>
        <pc:cxnChg chg="add mod">
          <ac:chgData name="Sadaf Naqvi" userId="8f91277e-8741-4995-819e-50b4e5326a9f" providerId="ADAL" clId="{5361019A-BF92-4CDD-805D-01D6A06CCAF2}" dt="2024-11-14T08:58:43.892" v="470" actId="1076"/>
          <ac:cxnSpMkLst>
            <pc:docMk/>
            <pc:sldMk cId="1453174751" sldId="259"/>
            <ac:cxnSpMk id="43" creationId="{7CBA9AA6-B2F7-30E8-5357-86C37DA86C8F}"/>
          </ac:cxnSpMkLst>
        </pc:cxnChg>
        <pc:cxnChg chg="add mod">
          <ac:chgData name="Sadaf Naqvi" userId="8f91277e-8741-4995-819e-50b4e5326a9f" providerId="ADAL" clId="{5361019A-BF92-4CDD-805D-01D6A06CCAF2}" dt="2024-11-14T09:00:43.835" v="491" actId="164"/>
          <ac:cxnSpMkLst>
            <pc:docMk/>
            <pc:sldMk cId="1453174751" sldId="259"/>
            <ac:cxnSpMk id="45" creationId="{57299F36-D8FA-452C-E20D-28D97B034C7D}"/>
          </ac:cxnSpMkLst>
        </pc:cxnChg>
        <pc:cxnChg chg="add mod">
          <ac:chgData name="Sadaf Naqvi" userId="8f91277e-8741-4995-819e-50b4e5326a9f" providerId="ADAL" clId="{5361019A-BF92-4CDD-805D-01D6A06CCAF2}" dt="2024-11-14T09:00:43.835" v="491" actId="164"/>
          <ac:cxnSpMkLst>
            <pc:docMk/>
            <pc:sldMk cId="1453174751" sldId="259"/>
            <ac:cxnSpMk id="47" creationId="{2D699CA4-875F-92E7-AD7F-6119D3F53174}"/>
          </ac:cxnSpMkLst>
        </pc:cxnChg>
        <pc:cxnChg chg="add del mod">
          <ac:chgData name="Sadaf Naqvi" userId="8f91277e-8741-4995-819e-50b4e5326a9f" providerId="ADAL" clId="{5361019A-BF92-4CDD-805D-01D6A06CCAF2}" dt="2024-11-14T08:59:48.468" v="484" actId="478"/>
          <ac:cxnSpMkLst>
            <pc:docMk/>
            <pc:sldMk cId="1453174751" sldId="259"/>
            <ac:cxnSpMk id="48" creationId="{24C380FD-0569-1F7F-A704-26D3E7EBE095}"/>
          </ac:cxnSpMkLst>
        </pc:cxnChg>
        <pc:cxnChg chg="add mod">
          <ac:chgData name="Sadaf Naqvi" userId="8f91277e-8741-4995-819e-50b4e5326a9f" providerId="ADAL" clId="{5361019A-BF92-4CDD-805D-01D6A06CCAF2}" dt="2024-11-14T09:00:43.835" v="491" actId="164"/>
          <ac:cxnSpMkLst>
            <pc:docMk/>
            <pc:sldMk cId="1453174751" sldId="259"/>
            <ac:cxnSpMk id="53" creationId="{4BA228DD-BC8B-3C9A-9D89-0CA9081FCC49}"/>
          </ac:cxnSpMkLst>
        </pc:cxnChg>
        <pc:cxnChg chg="add mod">
          <ac:chgData name="Sadaf Naqvi" userId="8f91277e-8741-4995-819e-50b4e5326a9f" providerId="ADAL" clId="{5361019A-BF92-4CDD-805D-01D6A06CCAF2}" dt="2024-11-14T09:00:43.835" v="491" actId="164"/>
          <ac:cxnSpMkLst>
            <pc:docMk/>
            <pc:sldMk cId="1453174751" sldId="259"/>
            <ac:cxnSpMk id="54" creationId="{D88162E4-76CD-3B5A-ACA8-D03988EEB0D9}"/>
          </ac:cxnSpMkLst>
        </pc:cxnChg>
        <pc:cxnChg chg="mod">
          <ac:chgData name="Sadaf Naqvi" userId="8f91277e-8741-4995-819e-50b4e5326a9f" providerId="ADAL" clId="{5361019A-BF92-4CDD-805D-01D6A06CCAF2}" dt="2024-11-14T09:00:47.654" v="492"/>
          <ac:cxnSpMkLst>
            <pc:docMk/>
            <pc:sldMk cId="1453174751" sldId="259"/>
            <ac:cxnSpMk id="58" creationId="{7E115793-EABA-1DD4-563A-4BB5C96F15CA}"/>
          </ac:cxnSpMkLst>
        </pc:cxnChg>
        <pc:cxnChg chg="mod">
          <ac:chgData name="Sadaf Naqvi" userId="8f91277e-8741-4995-819e-50b4e5326a9f" providerId="ADAL" clId="{5361019A-BF92-4CDD-805D-01D6A06CCAF2}" dt="2024-11-14T09:00:47.654" v="492"/>
          <ac:cxnSpMkLst>
            <pc:docMk/>
            <pc:sldMk cId="1453174751" sldId="259"/>
            <ac:cxnSpMk id="59" creationId="{810D9E2F-D0A8-3D90-F1E1-040C60C41597}"/>
          </ac:cxnSpMkLst>
        </pc:cxnChg>
        <pc:cxnChg chg="mod">
          <ac:chgData name="Sadaf Naqvi" userId="8f91277e-8741-4995-819e-50b4e5326a9f" providerId="ADAL" clId="{5361019A-BF92-4CDD-805D-01D6A06CCAF2}" dt="2024-11-14T09:00:47.654" v="492"/>
          <ac:cxnSpMkLst>
            <pc:docMk/>
            <pc:sldMk cId="1453174751" sldId="259"/>
            <ac:cxnSpMk id="60" creationId="{FAF95213-8671-E601-A135-6D34C70DB9E7}"/>
          </ac:cxnSpMkLst>
        </pc:cxnChg>
        <pc:cxnChg chg="mod">
          <ac:chgData name="Sadaf Naqvi" userId="8f91277e-8741-4995-819e-50b4e5326a9f" providerId="ADAL" clId="{5361019A-BF92-4CDD-805D-01D6A06CCAF2}" dt="2024-11-14T09:00:47.654" v="492"/>
          <ac:cxnSpMkLst>
            <pc:docMk/>
            <pc:sldMk cId="1453174751" sldId="259"/>
            <ac:cxnSpMk id="61" creationId="{A8C81FFF-4367-885F-EFD0-2647939D92A8}"/>
          </ac:cxnSpMkLst>
        </pc:cxnChg>
        <pc:cxnChg chg="mod">
          <ac:chgData name="Sadaf Naqvi" userId="8f91277e-8741-4995-819e-50b4e5326a9f" providerId="ADAL" clId="{5361019A-BF92-4CDD-805D-01D6A06CCAF2}" dt="2024-11-14T09:00:53.233" v="494"/>
          <ac:cxnSpMkLst>
            <pc:docMk/>
            <pc:sldMk cId="1453174751" sldId="259"/>
            <ac:cxnSpMk id="63" creationId="{F5EE7167-66B2-5228-436A-14E8EDCC12AC}"/>
          </ac:cxnSpMkLst>
        </pc:cxnChg>
        <pc:cxnChg chg="mod">
          <ac:chgData name="Sadaf Naqvi" userId="8f91277e-8741-4995-819e-50b4e5326a9f" providerId="ADAL" clId="{5361019A-BF92-4CDD-805D-01D6A06CCAF2}" dt="2024-11-14T09:00:53.233" v="494"/>
          <ac:cxnSpMkLst>
            <pc:docMk/>
            <pc:sldMk cId="1453174751" sldId="259"/>
            <ac:cxnSpMk id="64" creationId="{435E0073-BED9-CA32-A292-8AB07A215248}"/>
          </ac:cxnSpMkLst>
        </pc:cxnChg>
        <pc:cxnChg chg="mod">
          <ac:chgData name="Sadaf Naqvi" userId="8f91277e-8741-4995-819e-50b4e5326a9f" providerId="ADAL" clId="{5361019A-BF92-4CDD-805D-01D6A06CCAF2}" dt="2024-11-14T09:00:53.233" v="494"/>
          <ac:cxnSpMkLst>
            <pc:docMk/>
            <pc:sldMk cId="1453174751" sldId="259"/>
            <ac:cxnSpMk id="65" creationId="{AB18AC90-0418-98AB-7B3C-28D0B78BCCB2}"/>
          </ac:cxnSpMkLst>
        </pc:cxnChg>
        <pc:cxnChg chg="mod">
          <ac:chgData name="Sadaf Naqvi" userId="8f91277e-8741-4995-819e-50b4e5326a9f" providerId="ADAL" clId="{5361019A-BF92-4CDD-805D-01D6A06CCAF2}" dt="2024-11-14T09:00:53.233" v="494"/>
          <ac:cxnSpMkLst>
            <pc:docMk/>
            <pc:sldMk cId="1453174751" sldId="259"/>
            <ac:cxnSpMk id="66" creationId="{DE7C9D04-9C83-30A5-A64F-1FDB34E0CB07}"/>
          </ac:cxnSpMkLst>
        </pc:cxnChg>
      </pc:sldChg>
      <pc:sldChg chg="add del">
        <pc:chgData name="Sadaf Naqvi" userId="8f91277e-8741-4995-819e-50b4e5326a9f" providerId="ADAL" clId="{5361019A-BF92-4CDD-805D-01D6A06CCAF2}" dt="2024-11-14T08:46:13.072" v="17" actId="2696"/>
        <pc:sldMkLst>
          <pc:docMk/>
          <pc:sldMk cId="2459421142" sldId="260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68C48D-A486-6E89-6C7A-DC833FB704A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709A8B7-7800-1F97-2344-E131617DFD0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C366FD-B4DB-7EB3-69FA-70BDCA504C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64FAAD-A448-519A-AC74-50CBFBD97F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9D17C6-AFC6-52D8-5D09-37C200C8C4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42300535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20367E-44C3-D1F7-62F1-54693037B3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EA70232-D37C-8C45-3A9C-D7D5350FCB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7FFC4D-41FB-8A01-C48C-9E7AB14341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D29CD3-BA08-0FC5-BB65-2EF7CAEF81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00B12C-0D6F-5AC1-F8ED-37D2569C3A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33070444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3D219A9-A91D-C7A5-6CBD-D0B41679C7A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1E5AA97-77DB-C15D-C0D5-957D75A9559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BCB0CF-3EDD-7C6D-DEB6-7549EFB1DE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8D1FB4-5087-A930-5B78-8BF0826086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24C854-BD81-F980-759A-021C54D2DB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34172468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DC1290-586E-2DDF-F1DA-C4EA47D6C1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349588F-3FF8-65AA-A891-CCD573DF011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BFCD04-BFDA-C0C3-43C4-94C469968E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1D8EFA-A88B-96B4-FF06-8B64917C15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1DC422-253A-BB67-0AF2-1E99BEA21B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39244143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A28A11-838D-D2DD-55B4-6C63FA743A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CD0C543-2535-07EB-B2F0-3312E7BF01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B32F60-B38A-792B-5C0F-5D7DDFC8FE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9901F2-3097-0969-8A91-2389629594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00D6CD-716B-DDAE-9196-7A976DC3AF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20076012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DACE48-9899-EED3-1FC4-4840D8326C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13CD23E-A8B0-A862-1CD6-9F19A2B6447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2BA0B39-F16D-D778-642D-3F7907FC26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F30BB97-F3DD-F112-1284-8E370C5F05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8E3B947-9CFA-9355-9938-83716C32E7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6094360-C2EE-15FC-9D07-C95C64E553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31788342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09226A-3E98-6E2C-6076-76A840B382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33905A3-2FD2-E093-6C79-E6082BC952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AAD6E32-8D3C-04CF-B236-F1EB000A8B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16B2E07-3657-7CE3-071E-AE718497199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0B4621F-129A-4765-2034-2AC1BC7AF71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177AA78-6B7C-05E0-DBD1-54C009C869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4D5CBAC-CF07-E87F-EA51-5447FD63E3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D04EC99-3FC4-2CCC-AB2C-480CF7ACCB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37384713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E9A408-574A-C2D3-DBE3-4FBB9E05FA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293148F-C0CD-D23A-2717-216D09552A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ED63BCC-DBA8-D378-4D42-0F379F7DDD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DE92133-D309-DEED-0999-67A24FC01B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9420593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BE16AF3-921C-DF98-4624-AC09DE867E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A197E7C-B0F6-F9A3-8683-4A9337C173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3450C66-C365-F829-171C-02C62AA33B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19817531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EDF864-A919-6F29-1BD7-5CFEB91D1F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C10DAE7-6B29-965F-37F8-149486260BE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CEABF2F-38E4-0EE4-9996-53BFE050E63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689D6B5-9D01-F30D-4159-55F9DBD593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ADFDA9-F64B-1FFD-789B-2C0A843622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41AE6F0-13C2-3050-C08A-0E61BCD8A2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534638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3F4C22-D012-ADED-149E-2EECDBE470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5A5229D-5729-4C84-A459-AC2F81ADA9F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F9B3EC1-9AC3-71DC-3152-2C31E60DDF5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37BE77-09DB-BE68-F16D-51E0EF0331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6159977-7F6B-276B-0522-F5E17DEF00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57D6283-0C91-BE41-CDC0-5822DEB603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18214845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443B1B0-CD18-7AA8-63A5-F312D126B9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A39DD10-F90E-FC0F-E0DE-6A4CB3E626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EA191F-B78C-5713-36C0-FC9FA45A587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28C02B-9201-A477-6705-D22C8BD4B6B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A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321A6F-A45E-93A5-4616-55CCBD971CE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35768061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9C5A39-AD4F-1D04-8BB5-29F52A4118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200" dirty="0"/>
              <a:t>Figure 2: Program Workflow for utilizing the Real-Time AI-Powered Dashboard to manage  No-Show and reduce waiting times in Primary Healthcare, EHS, UAE</a:t>
            </a:r>
            <a:endParaRPr lang="en-AE" dirty="0"/>
          </a:p>
        </p:txBody>
      </p:sp>
      <p:sp>
        <p:nvSpPr>
          <p:cNvPr id="4" name="Flowchart: Process 3">
            <a:extLst>
              <a:ext uri="{FF2B5EF4-FFF2-40B4-BE49-F238E27FC236}">
                <a16:creationId xmlns:a16="http://schemas.microsoft.com/office/drawing/2014/main" id="{0AE6096C-A769-2A69-AC59-2F70E39B37BF}"/>
              </a:ext>
            </a:extLst>
          </p:cNvPr>
          <p:cNvSpPr/>
          <p:nvPr/>
        </p:nvSpPr>
        <p:spPr>
          <a:xfrm>
            <a:off x="4114800" y="1690688"/>
            <a:ext cx="2935224" cy="604456"/>
          </a:xfrm>
          <a:prstGeom prst="flowChartProcess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E"/>
          </a:p>
        </p:txBody>
      </p:sp>
      <p:sp>
        <p:nvSpPr>
          <p:cNvPr id="5" name="Flowchart: Process 4">
            <a:extLst>
              <a:ext uri="{FF2B5EF4-FFF2-40B4-BE49-F238E27FC236}">
                <a16:creationId xmlns:a16="http://schemas.microsoft.com/office/drawing/2014/main" id="{928A6FFF-3A73-A755-ED9A-0EBEDF165257}"/>
              </a:ext>
            </a:extLst>
          </p:cNvPr>
          <p:cNvSpPr/>
          <p:nvPr/>
        </p:nvSpPr>
        <p:spPr>
          <a:xfrm>
            <a:off x="1106424" y="2682495"/>
            <a:ext cx="1600200" cy="667512"/>
          </a:xfrm>
          <a:prstGeom prst="flowChartProcess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E"/>
          </a:p>
        </p:txBody>
      </p:sp>
      <p:sp>
        <p:nvSpPr>
          <p:cNvPr id="6" name="Flowchart: Process 5">
            <a:extLst>
              <a:ext uri="{FF2B5EF4-FFF2-40B4-BE49-F238E27FC236}">
                <a16:creationId xmlns:a16="http://schemas.microsoft.com/office/drawing/2014/main" id="{F5FCFD82-A3A2-815F-67F9-929404DEF833}"/>
              </a:ext>
            </a:extLst>
          </p:cNvPr>
          <p:cNvSpPr/>
          <p:nvPr/>
        </p:nvSpPr>
        <p:spPr>
          <a:xfrm>
            <a:off x="4971288" y="2682495"/>
            <a:ext cx="1600200" cy="667512"/>
          </a:xfrm>
          <a:prstGeom prst="flowChartProcess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E"/>
          </a:p>
        </p:txBody>
      </p:sp>
      <p:sp>
        <p:nvSpPr>
          <p:cNvPr id="7" name="Flowchart: Process 6">
            <a:extLst>
              <a:ext uri="{FF2B5EF4-FFF2-40B4-BE49-F238E27FC236}">
                <a16:creationId xmlns:a16="http://schemas.microsoft.com/office/drawing/2014/main" id="{1CF77738-D924-2A8C-8051-EECC1067359B}"/>
              </a:ext>
            </a:extLst>
          </p:cNvPr>
          <p:cNvSpPr/>
          <p:nvPr/>
        </p:nvSpPr>
        <p:spPr>
          <a:xfrm>
            <a:off x="9104376" y="2682495"/>
            <a:ext cx="1600200" cy="667512"/>
          </a:xfrm>
          <a:prstGeom prst="flowChartProcess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E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13C2876-5C6F-DF3D-1425-4176C96610EC}"/>
              </a:ext>
            </a:extLst>
          </p:cNvPr>
          <p:cNvSpPr txBox="1"/>
          <p:nvPr/>
        </p:nvSpPr>
        <p:spPr>
          <a:xfrm>
            <a:off x="4523232" y="1798495"/>
            <a:ext cx="2368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al Time Dashboard </a:t>
            </a:r>
            <a:endParaRPr lang="en-AE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39C2A00-AFCB-224C-68DF-DE325FC610DA}"/>
              </a:ext>
            </a:extLst>
          </p:cNvPr>
          <p:cNvSpPr txBox="1"/>
          <p:nvPr/>
        </p:nvSpPr>
        <p:spPr>
          <a:xfrm>
            <a:off x="1172156" y="2703676"/>
            <a:ext cx="146873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Waiting time </a:t>
            </a:r>
          </a:p>
          <a:p>
            <a:pPr algn="ctr"/>
            <a:r>
              <a:rPr lang="en-US" dirty="0"/>
              <a:t>Analytics</a:t>
            </a:r>
            <a:endParaRPr lang="en-AE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A321AF4-2542-7608-41ED-CD336D636C29}"/>
              </a:ext>
            </a:extLst>
          </p:cNvPr>
          <p:cNvSpPr txBox="1"/>
          <p:nvPr/>
        </p:nvSpPr>
        <p:spPr>
          <a:xfrm>
            <a:off x="5206137" y="2703676"/>
            <a:ext cx="113050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Resource</a:t>
            </a:r>
          </a:p>
          <a:p>
            <a:pPr algn="ctr"/>
            <a:r>
              <a:rPr lang="en-US" dirty="0"/>
              <a:t>Analytics</a:t>
            </a:r>
            <a:endParaRPr lang="en-AE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C41264C-F660-2E93-B27C-5411A1E1BB66}"/>
              </a:ext>
            </a:extLst>
          </p:cNvPr>
          <p:cNvSpPr txBox="1"/>
          <p:nvPr/>
        </p:nvSpPr>
        <p:spPr>
          <a:xfrm>
            <a:off x="9248175" y="2693085"/>
            <a:ext cx="13126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No-Show </a:t>
            </a:r>
          </a:p>
          <a:p>
            <a:pPr algn="ctr"/>
            <a:r>
              <a:rPr lang="en-US" dirty="0"/>
              <a:t>Predictions</a:t>
            </a:r>
            <a:endParaRPr lang="en-AE" dirty="0"/>
          </a:p>
        </p:txBody>
      </p:sp>
      <p:sp>
        <p:nvSpPr>
          <p:cNvPr id="12" name="Flowchart: Process 11">
            <a:extLst>
              <a:ext uri="{FF2B5EF4-FFF2-40B4-BE49-F238E27FC236}">
                <a16:creationId xmlns:a16="http://schemas.microsoft.com/office/drawing/2014/main" id="{14971E17-7F66-C107-2447-7DD0B78C98D5}"/>
              </a:ext>
            </a:extLst>
          </p:cNvPr>
          <p:cNvSpPr/>
          <p:nvPr/>
        </p:nvSpPr>
        <p:spPr>
          <a:xfrm>
            <a:off x="1104699" y="3674302"/>
            <a:ext cx="1600200" cy="667512"/>
          </a:xfrm>
          <a:prstGeom prst="flowChartProcess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E"/>
          </a:p>
        </p:txBody>
      </p:sp>
      <p:sp>
        <p:nvSpPr>
          <p:cNvPr id="13" name="Flowchart: Process 12">
            <a:extLst>
              <a:ext uri="{FF2B5EF4-FFF2-40B4-BE49-F238E27FC236}">
                <a16:creationId xmlns:a16="http://schemas.microsoft.com/office/drawing/2014/main" id="{8804DDC9-80DA-0163-C2D7-F668418F5EA2}"/>
              </a:ext>
            </a:extLst>
          </p:cNvPr>
          <p:cNvSpPr/>
          <p:nvPr/>
        </p:nvSpPr>
        <p:spPr>
          <a:xfrm>
            <a:off x="4971287" y="3674302"/>
            <a:ext cx="1600200" cy="667512"/>
          </a:xfrm>
          <a:prstGeom prst="flowChartProcess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E"/>
          </a:p>
        </p:txBody>
      </p:sp>
      <p:sp>
        <p:nvSpPr>
          <p:cNvPr id="14" name="Flowchart: Process 13">
            <a:extLst>
              <a:ext uri="{FF2B5EF4-FFF2-40B4-BE49-F238E27FC236}">
                <a16:creationId xmlns:a16="http://schemas.microsoft.com/office/drawing/2014/main" id="{FA2415E5-D269-57E6-B013-7445CBE03921}"/>
              </a:ext>
            </a:extLst>
          </p:cNvPr>
          <p:cNvSpPr/>
          <p:nvPr/>
        </p:nvSpPr>
        <p:spPr>
          <a:xfrm>
            <a:off x="9104376" y="3674302"/>
            <a:ext cx="1600200" cy="667512"/>
          </a:xfrm>
          <a:prstGeom prst="flowChartProcess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E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A9B2BD7-609B-F3C9-093B-704D6B1CB8FD}"/>
              </a:ext>
            </a:extLst>
          </p:cNvPr>
          <p:cNvSpPr txBox="1"/>
          <p:nvPr/>
        </p:nvSpPr>
        <p:spPr>
          <a:xfrm>
            <a:off x="1139550" y="3695483"/>
            <a:ext cx="146873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Increase in </a:t>
            </a:r>
          </a:p>
          <a:p>
            <a:pPr algn="ctr"/>
            <a:r>
              <a:rPr lang="en-US" dirty="0"/>
              <a:t>Waiting time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47EEA36-2431-DE89-1E0B-0C37A7D539DC}"/>
              </a:ext>
            </a:extLst>
          </p:cNvPr>
          <p:cNvSpPr txBox="1"/>
          <p:nvPr/>
        </p:nvSpPr>
        <p:spPr>
          <a:xfrm>
            <a:off x="5098515" y="3674302"/>
            <a:ext cx="134575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Resource </a:t>
            </a:r>
          </a:p>
          <a:p>
            <a:pPr algn="ctr"/>
            <a:r>
              <a:rPr lang="en-US" dirty="0"/>
              <a:t>Constraints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765BDC7-D00A-F961-C63F-290A371FD987}"/>
              </a:ext>
            </a:extLst>
          </p:cNvPr>
          <p:cNvSpPr txBox="1"/>
          <p:nvPr/>
        </p:nvSpPr>
        <p:spPr>
          <a:xfrm>
            <a:off x="9302443" y="3695483"/>
            <a:ext cx="128599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Patients at </a:t>
            </a:r>
          </a:p>
          <a:p>
            <a:pPr algn="ctr"/>
            <a:r>
              <a:rPr lang="en-US" dirty="0"/>
              <a:t>High risk</a:t>
            </a:r>
          </a:p>
        </p:txBody>
      </p:sp>
      <p:sp>
        <p:nvSpPr>
          <p:cNvPr id="18" name="Flowchart: Process 17">
            <a:extLst>
              <a:ext uri="{FF2B5EF4-FFF2-40B4-BE49-F238E27FC236}">
                <a16:creationId xmlns:a16="http://schemas.microsoft.com/office/drawing/2014/main" id="{B7DCF0C1-98B1-1162-3FBF-D08E85918193}"/>
              </a:ext>
            </a:extLst>
          </p:cNvPr>
          <p:cNvSpPr/>
          <p:nvPr/>
        </p:nvSpPr>
        <p:spPr>
          <a:xfrm>
            <a:off x="402336" y="4727448"/>
            <a:ext cx="1143000" cy="521208"/>
          </a:xfrm>
          <a:prstGeom prst="flowChartProcess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E"/>
          </a:p>
        </p:txBody>
      </p:sp>
      <p:sp>
        <p:nvSpPr>
          <p:cNvPr id="20" name="Flowchart: Process 19">
            <a:extLst>
              <a:ext uri="{FF2B5EF4-FFF2-40B4-BE49-F238E27FC236}">
                <a16:creationId xmlns:a16="http://schemas.microsoft.com/office/drawing/2014/main" id="{4577D8F2-4CA9-1059-664A-B6FF19D8F9CB}"/>
              </a:ext>
            </a:extLst>
          </p:cNvPr>
          <p:cNvSpPr/>
          <p:nvPr/>
        </p:nvSpPr>
        <p:spPr>
          <a:xfrm>
            <a:off x="1919637" y="4727448"/>
            <a:ext cx="1143000" cy="521208"/>
          </a:xfrm>
          <a:prstGeom prst="flowChartProcess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E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D23DFC5-0BB7-3073-B835-3F4250B23C30}"/>
              </a:ext>
            </a:extLst>
          </p:cNvPr>
          <p:cNvSpPr txBox="1"/>
          <p:nvPr/>
        </p:nvSpPr>
        <p:spPr>
          <a:xfrm>
            <a:off x="536783" y="4727448"/>
            <a:ext cx="85677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Staff </a:t>
            </a:r>
          </a:p>
          <a:p>
            <a:pPr algn="ctr"/>
            <a:r>
              <a:rPr lang="en-US" sz="1200" dirty="0"/>
              <a:t>relocation</a:t>
            </a:r>
            <a:endParaRPr lang="en-AE" sz="12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808A97A-F9F9-4F6B-5B32-FC49CDE9BC5D}"/>
              </a:ext>
            </a:extLst>
          </p:cNvPr>
          <p:cNvSpPr txBox="1"/>
          <p:nvPr/>
        </p:nvSpPr>
        <p:spPr>
          <a:xfrm>
            <a:off x="1964745" y="4695664"/>
            <a:ext cx="104579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Re-routing to</a:t>
            </a:r>
          </a:p>
          <a:p>
            <a:pPr algn="ctr"/>
            <a:r>
              <a:rPr lang="en-US" sz="1200" dirty="0"/>
              <a:t>Other PHC</a:t>
            </a:r>
            <a:endParaRPr lang="en-AE" sz="1200" dirty="0"/>
          </a:p>
        </p:txBody>
      </p:sp>
      <p:sp>
        <p:nvSpPr>
          <p:cNvPr id="24" name="Flowchart: Process 23">
            <a:extLst>
              <a:ext uri="{FF2B5EF4-FFF2-40B4-BE49-F238E27FC236}">
                <a16:creationId xmlns:a16="http://schemas.microsoft.com/office/drawing/2014/main" id="{58201475-2CCB-E270-2012-5767053FBC64}"/>
              </a:ext>
            </a:extLst>
          </p:cNvPr>
          <p:cNvSpPr/>
          <p:nvPr/>
        </p:nvSpPr>
        <p:spPr>
          <a:xfrm>
            <a:off x="4399787" y="4697892"/>
            <a:ext cx="1143000" cy="521208"/>
          </a:xfrm>
          <a:prstGeom prst="flowChartProcess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E"/>
          </a:p>
        </p:txBody>
      </p:sp>
      <p:sp>
        <p:nvSpPr>
          <p:cNvPr id="25" name="Flowchart: Process 24">
            <a:extLst>
              <a:ext uri="{FF2B5EF4-FFF2-40B4-BE49-F238E27FC236}">
                <a16:creationId xmlns:a16="http://schemas.microsoft.com/office/drawing/2014/main" id="{E47D2E80-C1E8-5220-F6EF-EEC960C1A26D}"/>
              </a:ext>
            </a:extLst>
          </p:cNvPr>
          <p:cNvSpPr/>
          <p:nvPr/>
        </p:nvSpPr>
        <p:spPr>
          <a:xfrm>
            <a:off x="6096000" y="4695664"/>
            <a:ext cx="1143000" cy="521208"/>
          </a:xfrm>
          <a:prstGeom prst="flowChartProcess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E"/>
          </a:p>
        </p:txBody>
      </p:sp>
      <p:sp>
        <p:nvSpPr>
          <p:cNvPr id="26" name="Flowchart: Process 25">
            <a:extLst>
              <a:ext uri="{FF2B5EF4-FFF2-40B4-BE49-F238E27FC236}">
                <a16:creationId xmlns:a16="http://schemas.microsoft.com/office/drawing/2014/main" id="{02C7F486-4B4A-F9B2-C8DC-85BB85F52FDA}"/>
              </a:ext>
            </a:extLst>
          </p:cNvPr>
          <p:cNvSpPr/>
          <p:nvPr/>
        </p:nvSpPr>
        <p:spPr>
          <a:xfrm>
            <a:off x="8532876" y="4666109"/>
            <a:ext cx="1143000" cy="521208"/>
          </a:xfrm>
          <a:prstGeom prst="flowChartProcess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E"/>
          </a:p>
        </p:txBody>
      </p:sp>
      <p:sp>
        <p:nvSpPr>
          <p:cNvPr id="27" name="Flowchart: Process 26">
            <a:extLst>
              <a:ext uri="{FF2B5EF4-FFF2-40B4-BE49-F238E27FC236}">
                <a16:creationId xmlns:a16="http://schemas.microsoft.com/office/drawing/2014/main" id="{F6113A5D-09F0-729A-5A32-50B5A5960CD4}"/>
              </a:ext>
            </a:extLst>
          </p:cNvPr>
          <p:cNvSpPr/>
          <p:nvPr/>
        </p:nvSpPr>
        <p:spPr>
          <a:xfrm>
            <a:off x="10398252" y="4666109"/>
            <a:ext cx="1143000" cy="521208"/>
          </a:xfrm>
          <a:prstGeom prst="flowChartProcess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E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09CF38A-B20E-08DD-994E-663895BBFA5B}"/>
              </a:ext>
            </a:extLst>
          </p:cNvPr>
          <p:cNvSpPr txBox="1"/>
          <p:nvPr/>
        </p:nvSpPr>
        <p:spPr>
          <a:xfrm>
            <a:off x="4432890" y="4720976"/>
            <a:ext cx="106978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Internal Staff </a:t>
            </a:r>
          </a:p>
          <a:p>
            <a:pPr algn="ctr"/>
            <a:r>
              <a:rPr lang="en-US" sz="1200" dirty="0"/>
              <a:t>relocation</a:t>
            </a:r>
            <a:endParaRPr lang="en-AE" sz="12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C3F84770-5E16-713C-F991-CC78574FAAD8}"/>
              </a:ext>
            </a:extLst>
          </p:cNvPr>
          <p:cNvSpPr txBox="1"/>
          <p:nvPr/>
        </p:nvSpPr>
        <p:spPr>
          <a:xfrm>
            <a:off x="6117381" y="4727447"/>
            <a:ext cx="110023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External Staff </a:t>
            </a:r>
          </a:p>
          <a:p>
            <a:pPr algn="ctr"/>
            <a:r>
              <a:rPr lang="en-US" sz="1200" dirty="0"/>
              <a:t>relocation</a:t>
            </a:r>
            <a:endParaRPr lang="en-AE" sz="12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9F35A1E-8B00-B17C-EE90-BF5C55781338}"/>
              </a:ext>
            </a:extLst>
          </p:cNvPr>
          <p:cNvSpPr txBox="1"/>
          <p:nvPr/>
        </p:nvSpPr>
        <p:spPr>
          <a:xfrm>
            <a:off x="8431210" y="4695664"/>
            <a:ext cx="134633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Convince patient </a:t>
            </a:r>
          </a:p>
          <a:p>
            <a:pPr algn="ctr"/>
            <a:r>
              <a:rPr lang="en-US" sz="1200" dirty="0"/>
              <a:t>to visit</a:t>
            </a:r>
            <a:endParaRPr lang="en-AE" sz="12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5C1436E-C490-EC1C-B748-D63C583D63A0}"/>
              </a:ext>
            </a:extLst>
          </p:cNvPr>
          <p:cNvSpPr txBox="1"/>
          <p:nvPr/>
        </p:nvSpPr>
        <p:spPr>
          <a:xfrm>
            <a:off x="10376253" y="4720975"/>
            <a:ext cx="1211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Allocate slot to </a:t>
            </a:r>
          </a:p>
          <a:p>
            <a:pPr algn="ctr"/>
            <a:r>
              <a:rPr lang="en-US" sz="1200" dirty="0"/>
              <a:t>another visit</a:t>
            </a:r>
            <a:endParaRPr lang="en-AE" sz="1200" dirty="0"/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61D863BC-EDB5-3BA6-6099-4C3B188E6BEE}"/>
              </a:ext>
            </a:extLst>
          </p:cNvPr>
          <p:cNvCxnSpPr>
            <a:stCxn id="4" idx="2"/>
          </p:cNvCxnSpPr>
          <p:nvPr/>
        </p:nvCxnSpPr>
        <p:spPr>
          <a:xfrm>
            <a:off x="5582412" y="2295144"/>
            <a:ext cx="0" cy="219456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1F1AF263-0350-BA87-ACDA-B239F5D1604F}"/>
              </a:ext>
            </a:extLst>
          </p:cNvPr>
          <p:cNvCxnSpPr/>
          <p:nvPr/>
        </p:nvCxnSpPr>
        <p:spPr>
          <a:xfrm>
            <a:off x="2198151" y="2514600"/>
            <a:ext cx="7363525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6D907DD3-61A1-C552-3E53-F7F67CEE2E83}"/>
              </a:ext>
            </a:extLst>
          </p:cNvPr>
          <p:cNvCxnSpPr/>
          <p:nvPr/>
        </p:nvCxnSpPr>
        <p:spPr>
          <a:xfrm>
            <a:off x="2185416" y="2514600"/>
            <a:ext cx="0" cy="16789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C9A459DE-E50E-96F6-4B30-02E4C09B1FA2}"/>
              </a:ext>
            </a:extLst>
          </p:cNvPr>
          <p:cNvCxnSpPr/>
          <p:nvPr/>
        </p:nvCxnSpPr>
        <p:spPr>
          <a:xfrm>
            <a:off x="5582412" y="2514599"/>
            <a:ext cx="0" cy="16789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165AC379-1BBB-A7AC-7F12-299052C93F1C}"/>
              </a:ext>
            </a:extLst>
          </p:cNvPr>
          <p:cNvCxnSpPr/>
          <p:nvPr/>
        </p:nvCxnSpPr>
        <p:spPr>
          <a:xfrm>
            <a:off x="9561676" y="2513202"/>
            <a:ext cx="0" cy="16789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894E7169-44C2-8785-91B0-632F5CE482DC}"/>
              </a:ext>
            </a:extLst>
          </p:cNvPr>
          <p:cNvCxnSpPr>
            <a:cxnSpLocks/>
            <a:endCxn id="15" idx="0"/>
          </p:cNvCxnSpPr>
          <p:nvPr/>
        </p:nvCxnSpPr>
        <p:spPr>
          <a:xfrm>
            <a:off x="1873917" y="3343656"/>
            <a:ext cx="1" cy="351827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DC592D87-DEF6-952B-5D8A-5CB41BD7CE70}"/>
              </a:ext>
            </a:extLst>
          </p:cNvPr>
          <p:cNvCxnSpPr>
            <a:cxnSpLocks/>
          </p:cNvCxnSpPr>
          <p:nvPr/>
        </p:nvCxnSpPr>
        <p:spPr>
          <a:xfrm>
            <a:off x="5771387" y="3331986"/>
            <a:ext cx="1" cy="351827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7CBA9AA6-B2F7-30E8-5357-86C37DA86C8F}"/>
              </a:ext>
            </a:extLst>
          </p:cNvPr>
          <p:cNvCxnSpPr>
            <a:cxnSpLocks/>
          </p:cNvCxnSpPr>
          <p:nvPr/>
        </p:nvCxnSpPr>
        <p:spPr>
          <a:xfrm>
            <a:off x="9884797" y="3313304"/>
            <a:ext cx="1" cy="351827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56" name="Group 55">
            <a:extLst>
              <a:ext uri="{FF2B5EF4-FFF2-40B4-BE49-F238E27FC236}">
                <a16:creationId xmlns:a16="http://schemas.microsoft.com/office/drawing/2014/main" id="{639A02B2-53F8-5DDE-7338-2B2986772C0F}"/>
              </a:ext>
            </a:extLst>
          </p:cNvPr>
          <p:cNvGrpSpPr/>
          <p:nvPr/>
        </p:nvGrpSpPr>
        <p:grpSpPr>
          <a:xfrm>
            <a:off x="1139550" y="4341814"/>
            <a:ext cx="1256178" cy="324295"/>
            <a:chOff x="1139550" y="4341814"/>
            <a:chExt cx="1256178" cy="324295"/>
          </a:xfrm>
        </p:grpSpPr>
        <p:cxnSp>
          <p:nvCxnSpPr>
            <p:cNvPr id="45" name="Straight Connector 44">
              <a:extLst>
                <a:ext uri="{FF2B5EF4-FFF2-40B4-BE49-F238E27FC236}">
                  <a16:creationId xmlns:a16="http://schemas.microsoft.com/office/drawing/2014/main" id="{57299F36-D8FA-452C-E20D-28D97B034C7D}"/>
                </a:ext>
              </a:extLst>
            </p:cNvPr>
            <p:cNvCxnSpPr>
              <a:stCxn id="15" idx="2"/>
            </p:cNvCxnSpPr>
            <p:nvPr/>
          </p:nvCxnSpPr>
          <p:spPr>
            <a:xfrm flipH="1">
              <a:off x="1873917" y="4341814"/>
              <a:ext cx="1" cy="147890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2D699CA4-875F-92E7-AD7F-6119D3F53174}"/>
                </a:ext>
              </a:extLst>
            </p:cNvPr>
            <p:cNvCxnSpPr>
              <a:cxnSpLocks/>
            </p:cNvCxnSpPr>
            <p:nvPr/>
          </p:nvCxnSpPr>
          <p:spPr>
            <a:xfrm>
              <a:off x="1139550" y="4489704"/>
              <a:ext cx="1256178" cy="0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Arrow Connector 52">
              <a:extLst>
                <a:ext uri="{FF2B5EF4-FFF2-40B4-BE49-F238E27FC236}">
                  <a16:creationId xmlns:a16="http://schemas.microsoft.com/office/drawing/2014/main" id="{4BA228DD-BC8B-3C9A-9D89-0CA9081FCC49}"/>
                </a:ext>
              </a:extLst>
            </p:cNvPr>
            <p:cNvCxnSpPr/>
            <p:nvPr/>
          </p:nvCxnSpPr>
          <p:spPr>
            <a:xfrm>
              <a:off x="1139550" y="4489704"/>
              <a:ext cx="0" cy="176405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Arrow Connector 53">
              <a:extLst>
                <a:ext uri="{FF2B5EF4-FFF2-40B4-BE49-F238E27FC236}">
                  <a16:creationId xmlns:a16="http://schemas.microsoft.com/office/drawing/2014/main" id="{D88162E4-76CD-3B5A-ACA8-D03988EEB0D9}"/>
                </a:ext>
              </a:extLst>
            </p:cNvPr>
            <p:cNvCxnSpPr/>
            <p:nvPr/>
          </p:nvCxnSpPr>
          <p:spPr>
            <a:xfrm>
              <a:off x="2395728" y="4489704"/>
              <a:ext cx="0" cy="176405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7" name="Group 56">
            <a:extLst>
              <a:ext uri="{FF2B5EF4-FFF2-40B4-BE49-F238E27FC236}">
                <a16:creationId xmlns:a16="http://schemas.microsoft.com/office/drawing/2014/main" id="{F11DF799-9CF3-A234-66D0-2BF30A1FE3AB}"/>
              </a:ext>
            </a:extLst>
          </p:cNvPr>
          <p:cNvGrpSpPr/>
          <p:nvPr/>
        </p:nvGrpSpPr>
        <p:grpSpPr>
          <a:xfrm>
            <a:off x="5080460" y="4341814"/>
            <a:ext cx="1256178" cy="324295"/>
            <a:chOff x="1139550" y="4341814"/>
            <a:chExt cx="1256178" cy="324295"/>
          </a:xfrm>
        </p:grpSpPr>
        <p:cxnSp>
          <p:nvCxnSpPr>
            <p:cNvPr id="58" name="Straight Connector 57">
              <a:extLst>
                <a:ext uri="{FF2B5EF4-FFF2-40B4-BE49-F238E27FC236}">
                  <a16:creationId xmlns:a16="http://schemas.microsoft.com/office/drawing/2014/main" id="{7E115793-EABA-1DD4-563A-4BB5C96F15CA}"/>
                </a:ext>
              </a:extLst>
            </p:cNvPr>
            <p:cNvCxnSpPr/>
            <p:nvPr/>
          </p:nvCxnSpPr>
          <p:spPr>
            <a:xfrm flipH="1">
              <a:off x="1873917" y="4341814"/>
              <a:ext cx="1" cy="147890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Straight Connector 58">
              <a:extLst>
                <a:ext uri="{FF2B5EF4-FFF2-40B4-BE49-F238E27FC236}">
                  <a16:creationId xmlns:a16="http://schemas.microsoft.com/office/drawing/2014/main" id="{810D9E2F-D0A8-3D90-F1E1-040C60C41597}"/>
                </a:ext>
              </a:extLst>
            </p:cNvPr>
            <p:cNvCxnSpPr>
              <a:cxnSpLocks/>
            </p:cNvCxnSpPr>
            <p:nvPr/>
          </p:nvCxnSpPr>
          <p:spPr>
            <a:xfrm>
              <a:off x="1139550" y="4489704"/>
              <a:ext cx="1256178" cy="0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Straight Arrow Connector 59">
              <a:extLst>
                <a:ext uri="{FF2B5EF4-FFF2-40B4-BE49-F238E27FC236}">
                  <a16:creationId xmlns:a16="http://schemas.microsoft.com/office/drawing/2014/main" id="{FAF95213-8671-E601-A135-6D34C70DB9E7}"/>
                </a:ext>
              </a:extLst>
            </p:cNvPr>
            <p:cNvCxnSpPr/>
            <p:nvPr/>
          </p:nvCxnSpPr>
          <p:spPr>
            <a:xfrm>
              <a:off x="1139550" y="4489704"/>
              <a:ext cx="0" cy="176405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Arrow Connector 60">
              <a:extLst>
                <a:ext uri="{FF2B5EF4-FFF2-40B4-BE49-F238E27FC236}">
                  <a16:creationId xmlns:a16="http://schemas.microsoft.com/office/drawing/2014/main" id="{A8C81FFF-4367-885F-EFD0-2647939D92A8}"/>
                </a:ext>
              </a:extLst>
            </p:cNvPr>
            <p:cNvCxnSpPr/>
            <p:nvPr/>
          </p:nvCxnSpPr>
          <p:spPr>
            <a:xfrm>
              <a:off x="2395728" y="4489704"/>
              <a:ext cx="0" cy="176405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2" name="Group 61">
            <a:extLst>
              <a:ext uri="{FF2B5EF4-FFF2-40B4-BE49-F238E27FC236}">
                <a16:creationId xmlns:a16="http://schemas.microsoft.com/office/drawing/2014/main" id="{7B3E6414-E5BF-647A-4892-14AD134CA126}"/>
              </a:ext>
            </a:extLst>
          </p:cNvPr>
          <p:cNvGrpSpPr/>
          <p:nvPr/>
        </p:nvGrpSpPr>
        <p:grpSpPr>
          <a:xfrm>
            <a:off x="9186303" y="4341381"/>
            <a:ext cx="1256178" cy="324295"/>
            <a:chOff x="1139550" y="4341814"/>
            <a:chExt cx="1256178" cy="324295"/>
          </a:xfrm>
        </p:grpSpPr>
        <p:cxnSp>
          <p:nvCxnSpPr>
            <p:cNvPr id="63" name="Straight Connector 62">
              <a:extLst>
                <a:ext uri="{FF2B5EF4-FFF2-40B4-BE49-F238E27FC236}">
                  <a16:creationId xmlns:a16="http://schemas.microsoft.com/office/drawing/2014/main" id="{F5EE7167-66B2-5228-436A-14E8EDCC12AC}"/>
                </a:ext>
              </a:extLst>
            </p:cNvPr>
            <p:cNvCxnSpPr/>
            <p:nvPr/>
          </p:nvCxnSpPr>
          <p:spPr>
            <a:xfrm flipH="1">
              <a:off x="1873917" y="4341814"/>
              <a:ext cx="1" cy="147890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Straight Connector 63">
              <a:extLst>
                <a:ext uri="{FF2B5EF4-FFF2-40B4-BE49-F238E27FC236}">
                  <a16:creationId xmlns:a16="http://schemas.microsoft.com/office/drawing/2014/main" id="{435E0073-BED9-CA32-A292-8AB07A215248}"/>
                </a:ext>
              </a:extLst>
            </p:cNvPr>
            <p:cNvCxnSpPr>
              <a:cxnSpLocks/>
            </p:cNvCxnSpPr>
            <p:nvPr/>
          </p:nvCxnSpPr>
          <p:spPr>
            <a:xfrm>
              <a:off x="1139550" y="4489704"/>
              <a:ext cx="1256178" cy="0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Straight Arrow Connector 64">
              <a:extLst>
                <a:ext uri="{FF2B5EF4-FFF2-40B4-BE49-F238E27FC236}">
                  <a16:creationId xmlns:a16="http://schemas.microsoft.com/office/drawing/2014/main" id="{AB18AC90-0418-98AB-7B3C-28D0B78BCCB2}"/>
                </a:ext>
              </a:extLst>
            </p:cNvPr>
            <p:cNvCxnSpPr/>
            <p:nvPr/>
          </p:nvCxnSpPr>
          <p:spPr>
            <a:xfrm>
              <a:off x="1139550" y="4489704"/>
              <a:ext cx="0" cy="176405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Arrow Connector 65">
              <a:extLst>
                <a:ext uri="{FF2B5EF4-FFF2-40B4-BE49-F238E27FC236}">
                  <a16:creationId xmlns:a16="http://schemas.microsoft.com/office/drawing/2014/main" id="{DE7C9D04-9C83-30A5-A64F-1FDB34E0CB07}"/>
                </a:ext>
              </a:extLst>
            </p:cNvPr>
            <p:cNvCxnSpPr/>
            <p:nvPr/>
          </p:nvCxnSpPr>
          <p:spPr>
            <a:xfrm>
              <a:off x="2395728" y="4489704"/>
              <a:ext cx="0" cy="176405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4531747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8</TotalTime>
  <Words>66</Words>
  <Application>Microsoft Office PowerPoint</Application>
  <PresentationFormat>Widescreen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Figure 2: Program Workflow for utilizing the Real-Time AI-Powered Dashboard to manage  No-Show and reduce waiting times in Primary Healthcare, EHS, UAE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adaf Naqvi</dc:creator>
  <cp:lastModifiedBy>Sadaf Naqvi</cp:lastModifiedBy>
  <cp:revision>1</cp:revision>
  <dcterms:created xsi:type="dcterms:W3CDTF">2024-11-06T09:04:20Z</dcterms:created>
  <dcterms:modified xsi:type="dcterms:W3CDTF">2024-11-14T09:01:0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3c76ce46-357f-46de-88d6-77b9bbb83c46_Enabled">
    <vt:lpwstr>true</vt:lpwstr>
  </property>
  <property fmtid="{D5CDD505-2E9C-101B-9397-08002B2CF9AE}" pid="3" name="MSIP_Label_3c76ce46-357f-46de-88d6-77b9bbb83c46_SetDate">
    <vt:lpwstr>2024-11-06T09:05:46Z</vt:lpwstr>
  </property>
  <property fmtid="{D5CDD505-2E9C-101B-9397-08002B2CF9AE}" pid="4" name="MSIP_Label_3c76ce46-357f-46de-88d6-77b9bbb83c46_Method">
    <vt:lpwstr>Privileged</vt:lpwstr>
  </property>
  <property fmtid="{D5CDD505-2E9C-101B-9397-08002B2CF9AE}" pid="5" name="MSIP_Label_3c76ce46-357f-46de-88d6-77b9bbb83c46_Name">
    <vt:lpwstr>Public</vt:lpwstr>
  </property>
  <property fmtid="{D5CDD505-2E9C-101B-9397-08002B2CF9AE}" pid="6" name="MSIP_Label_3c76ce46-357f-46de-88d6-77b9bbb83c46_SiteId">
    <vt:lpwstr>4e2c6054-71cb-48f1-bd6c-3a9705aca71b</vt:lpwstr>
  </property>
  <property fmtid="{D5CDD505-2E9C-101B-9397-08002B2CF9AE}" pid="7" name="MSIP_Label_3c76ce46-357f-46de-88d6-77b9bbb83c46_ActionId">
    <vt:lpwstr>6109e0eb-3837-46db-a36e-5089aca50507</vt:lpwstr>
  </property>
  <property fmtid="{D5CDD505-2E9C-101B-9397-08002B2CF9AE}" pid="8" name="MSIP_Label_3c76ce46-357f-46de-88d6-77b9bbb83c46_ContentBits">
    <vt:lpwstr>0</vt:lpwstr>
  </property>
</Properties>
</file>